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57"/>
    <p:restoredTop sz="94737"/>
  </p:normalViewPr>
  <p:slideViewPr>
    <p:cSldViewPr snapToGrid="0">
      <p:cViewPr varScale="1">
        <p:scale>
          <a:sx n="135" d="100"/>
          <a:sy n="135" d="100"/>
        </p:scale>
        <p:origin x="311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222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492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596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9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835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595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584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069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408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840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013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D85D01-5A8D-494A-A7F5-9EFD03DB5BDE}" type="datetimeFigureOut">
              <a:rPr lang="en-US" smtClean="0"/>
              <a:t>12/1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082824-F7B5-C948-B87B-336237EC6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850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397509F-224A-35A1-15BC-888721707E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828" y="3072695"/>
            <a:ext cx="6622344" cy="376061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6B65345-23F1-6810-A819-AB484F82BD0B}"/>
              </a:ext>
            </a:extLst>
          </p:cNvPr>
          <p:cNvSpPr txBox="1"/>
          <p:nvPr/>
        </p:nvSpPr>
        <p:spPr>
          <a:xfrm>
            <a:off x="117828" y="7264401"/>
            <a:ext cx="6622344" cy="263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M" sz="1100" b="1" dirty="0">
                <a:latin typeface="Helvetica" pitchFamily="2" charset="0"/>
              </a:rPr>
              <a:t>Supplemental Figure S2: </a:t>
            </a:r>
            <a:r>
              <a:rPr lang="en-IM" sz="1100" b="1" i="1" dirty="0">
                <a:latin typeface="Helvetica" pitchFamily="2" charset="0"/>
              </a:rPr>
              <a:t>Kalanchoë laxiflora </a:t>
            </a:r>
            <a:r>
              <a:rPr lang="en-IM" sz="1100" b="1" dirty="0">
                <a:latin typeface="Helvetica" pitchFamily="2" charset="0"/>
              </a:rPr>
              <a:t>accession OBG diploid displayed </a:t>
            </a:r>
            <a:r>
              <a:rPr lang="en-IM" sz="1100" b="1">
                <a:latin typeface="Helvetica" pitchFamily="2" charset="0"/>
              </a:rPr>
              <a:t>a robust and persistent </a:t>
            </a:r>
            <a:r>
              <a:rPr lang="en-IM" sz="1100" b="1" dirty="0">
                <a:latin typeface="Helvetica" pitchFamily="2" charset="0"/>
              </a:rPr>
              <a:t>circadian rhythm of CAM-associated CO</a:t>
            </a:r>
            <a:r>
              <a:rPr lang="en-IM" sz="1100" b="1" baseline="-25000" dirty="0">
                <a:latin typeface="Helvetica" pitchFamily="2" charset="0"/>
              </a:rPr>
              <a:t>2</a:t>
            </a:r>
            <a:r>
              <a:rPr lang="en-IM" sz="1100" b="1" dirty="0">
                <a:latin typeface="Helvetica" pitchFamily="2" charset="0"/>
              </a:rPr>
              <a:t> exchange under constant light and temperature (LL) free-running conditions. </a:t>
            </a:r>
            <a:r>
              <a:rPr lang="en-IM" sz="1100" dirty="0">
                <a:latin typeface="Helvetica" pitchFamily="2" charset="0"/>
              </a:rPr>
              <a:t>Three clonal mature plants that had been grown in a research glasshouse for 4-months under 16-h-light/ 8-h-dark were pre-entrained to 12-h-light/ 12-h-dark cycles in a Snijders Microclima MC-1000 plant growth cabinet (12-h-light period conditions: 450 µmoles photons m</a:t>
            </a:r>
            <a:r>
              <a:rPr lang="en-IM" sz="1100" baseline="30000" dirty="0">
                <a:latin typeface="Helvetica" pitchFamily="2" charset="0"/>
              </a:rPr>
              <a:t>-2</a:t>
            </a:r>
            <a:r>
              <a:rPr lang="en-IM" sz="1100" dirty="0">
                <a:latin typeface="Helvetica" pitchFamily="2" charset="0"/>
              </a:rPr>
              <a:t> s</a:t>
            </a:r>
            <a:r>
              <a:rPr lang="en-IM" sz="1100" baseline="30000" dirty="0">
                <a:latin typeface="Helvetica" pitchFamily="2" charset="0"/>
              </a:rPr>
              <a:t>-1</a:t>
            </a:r>
            <a:r>
              <a:rPr lang="en-IM" sz="1100" dirty="0">
                <a:latin typeface="Helvetica" pitchFamily="2" charset="0"/>
              </a:rPr>
              <a:t>, 25˚C, 70% humidity; 12-h-dark conditions: lights off, 15˚C, 70% humidity). Leaf pair 6 (LP6) were detached from the three clonal replicate plants and their petiole placed in distilled water immediately. Pairs of leaves were set up for measurements in the whole plant chambers of a bespoke CIRAS-DC-based, 12-channel, gas-switching infra-red gas analyser system, as described in Dever et al. (2015) and Boxall et al. (2020). Conditions during the experimental run were initially the same 12-h-light/ 12-h-dark used for pre-entrainment for the first 24-h, with the 12-h-dark period denoted by the darker grey background on the graph, and then the leaves were switched to LL condition after the first 24-h of LD. LL conditions were constant light (100 µmoles photons m</a:t>
            </a:r>
            <a:r>
              <a:rPr lang="en-IM" sz="1100" baseline="30000" dirty="0">
                <a:latin typeface="Helvetica" pitchFamily="2" charset="0"/>
              </a:rPr>
              <a:t>-2</a:t>
            </a:r>
            <a:r>
              <a:rPr lang="en-IM" sz="1100" dirty="0">
                <a:latin typeface="Helvetica" pitchFamily="2" charset="0"/>
              </a:rPr>
              <a:t> s</a:t>
            </a:r>
            <a:r>
              <a:rPr lang="en-IM" sz="1100" baseline="30000" dirty="0">
                <a:latin typeface="Helvetica" pitchFamily="2" charset="0"/>
              </a:rPr>
              <a:t>-1</a:t>
            </a:r>
            <a:r>
              <a:rPr lang="en-IM" sz="1100" dirty="0">
                <a:latin typeface="Helvetica" pitchFamily="2" charset="0"/>
              </a:rPr>
              <a:t>) at 15˚C and 70% humidity. The three biological replicate plants are plotted in black, red and blue.</a:t>
            </a:r>
            <a:endParaRPr lang="en-IM" sz="1100" b="1" dirty="0">
              <a:latin typeface="Helvetica" pitchFamily="2" charset="0"/>
            </a:endParaRPr>
          </a:p>
          <a:p>
            <a:r>
              <a:rPr lang="en-IM" sz="1100" b="1" dirty="0">
                <a:latin typeface="Helvetica" pitchFamily="2" charset="0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316956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</TotalTime>
  <Words>250</Words>
  <Application>Microsoft Macintosh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oxall, Susanna</dc:creator>
  <cp:lastModifiedBy>Hartwell, James</cp:lastModifiedBy>
  <cp:revision>6</cp:revision>
  <dcterms:created xsi:type="dcterms:W3CDTF">2024-12-18T15:52:54Z</dcterms:created>
  <dcterms:modified xsi:type="dcterms:W3CDTF">2024-12-19T11:22:06Z</dcterms:modified>
</cp:coreProperties>
</file>